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5A4A2-C41B-4006-AEF1-9B8CC77891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B21AC-DFB3-4B2E-BF9D-6E28F18C73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71BAB-9CFD-4ACF-B285-ABFD9D8725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9FC272-18DA-446C-B7B9-C301436A27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E8C02-7A1A-43D9-9AE7-0C5AA73546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22AEE-9103-4760-9433-6EDE2ED05F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EA869-2EF0-4980-BD9C-F1A1D08EB6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FB91C-B65E-45BB-B95B-9E2A2700F0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A0039-BC94-4DC1-A96C-040DDB6CDF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68B14-3742-46FF-B72B-8502A1D84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EE8209-B7EF-4CB5-A46E-0F2457A8F4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943F1-BC30-4E45-8D6E-CE4DB53FF3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E62C2D-992D-4E63-A887-14AE9F9EA4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03040" y="84240"/>
            <a:ext cx="8408520" cy="6459480"/>
            <a:chOff x="203040" y="84240"/>
            <a:chExt cx="8408520" cy="6459480"/>
          </a:xfrm>
        </p:grpSpPr>
        <p:sp>
          <p:nvSpPr>
            <p:cNvPr id="42" name=""/>
            <p:cNvSpPr/>
            <p:nvPr/>
          </p:nvSpPr>
          <p:spPr>
            <a:xfrm>
              <a:off x="718200" y="84240"/>
              <a:ext cx="5455440" cy="149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800" spc="-1" strike="noStrike">
                  <a:solidFill>
                    <a:srgbClr val="000000"/>
                  </a:solidFill>
                  <a:latin typeface="Arial"/>
                </a:rPr>
                <a:t>Additional file 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Test of the transfection efficiency of various transfection condition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Results of real-time PCR – relative quantifica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rot="5400000">
              <a:off x="6609240" y="4408920"/>
              <a:ext cx="6012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4" name=""/>
            <p:cNvGraphicFramePr/>
            <p:nvPr/>
          </p:nvGraphicFramePr>
          <p:xfrm>
            <a:off x="203040" y="1409760"/>
            <a:ext cx="7099560" cy="30099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03040" y="1409760"/>
                      <a:ext cx="7099560" cy="3009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" name=""/>
            <p:cNvSpPr/>
            <p:nvPr/>
          </p:nvSpPr>
          <p:spPr>
            <a:xfrm>
              <a:off x="454320" y="4989600"/>
              <a:ext cx="422280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a.  0.5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miR-1 [50µM}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b.  0.5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Negative Control [50 µ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c.  1.0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miR-1 [50µM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AutoNum type="alphaLcPeriod" startAt="4"/>
                <a:tabLst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Negative Control [50µM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AutoNum type="alphaLcPeriod" startAt="4"/>
                <a:tabLst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.75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miR-1 [50µM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AutoNum type="alphaLcPeriod" startAt="4"/>
                <a:tabLst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1.75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Negative Control [50 µ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AutoNum type="alphaLcPeriod" startAt="4"/>
                <a:tabLst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miR-1 [50µM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AutoNum type="alphaLcPeriod" startAt="4"/>
                <a:tabLst>
                  <a:tab algn="l" pos="541440"/>
                  <a:tab algn="l" pos="1082520"/>
                  <a:tab algn="l" pos="1623960"/>
                  <a:tab algn="l" pos="2165400"/>
                  <a:tab algn="l" pos="2706840"/>
                  <a:tab algn="l" pos="3247920"/>
                  <a:tab algn="l" pos="3789360"/>
                  <a:tab algn="l" pos="4330800"/>
                  <a:tab algn="l" pos="4871880"/>
                  <a:tab algn="l" pos="5413320"/>
                  <a:tab algn="l" pos="5954760"/>
                  <a:tab algn="l" pos="6496200"/>
                  <a:tab algn="l" pos="7037280"/>
                  <a:tab algn="l" pos="7578720"/>
                  <a:tab algn="l" pos="8120160"/>
                  <a:tab algn="l" pos="8661240"/>
                  <a:tab algn="l" pos="9202680"/>
                  <a:tab algn="l" pos="9744120"/>
                  <a:tab algn="l" pos="10285560"/>
                  <a:tab algn="l" pos="1082664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µl transfection agent + 4 µl Negative Control [50 µ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907520" y="4989600"/>
              <a:ext cx="370404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A.  1.0 µl transfection agent + 2 µl miR-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B.  1.0 µl transfection agent + 2 µl Negative Contro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C.  1.0 µl transfection agent + 4 µl miR-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D.  1.0 µl transfection agent + 4 µl Negative Control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E.  1.0 µl transfection agent + 6 µl miR-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F.  1.0 µl transfection agent + 6 µl Negativ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</a:rPr>
                <a:t>Mock: cells in culture medium only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309680" y="424980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722240" y="424980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101680" y="424980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490480" y="424980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285720" y="42498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876400" y="424980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432680" y="42498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834080" y="42498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213520" y="42498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624640" y="42498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375240" y="424980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988240" y="424980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654360" y="424980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078080" y="424980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3T18:30:41Z</dcterms:created>
  <dc:creator>mwagner</dc:creator>
  <dc:description/>
  <dc:language>en-US</dc:language>
  <cp:lastModifiedBy>mwagner</cp:lastModifiedBy>
  <dcterms:modified xsi:type="dcterms:W3CDTF">2009-11-22T19:03:52Z</dcterms:modified>
  <cp:revision>6</cp:revision>
  <dc:subject/>
  <dc:title>Folie 1</dc:title>
</cp:coreProperties>
</file>